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590" y="-325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0358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4246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6424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6272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4422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2287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791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6588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4355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7626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622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31967-7D95-4D6A-AC0F-6916AA4BAD26}" type="datetimeFigureOut">
              <a:rPr lang="en-GB" smtClean="0"/>
              <a:t>21/0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083213-3829-4635-B6B5-A7EEEFBC88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4545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5609" y="1319787"/>
            <a:ext cx="4532076" cy="334266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766222" y="5374848"/>
            <a:ext cx="553085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. AIV viral RNA load in lung macrophages from line 0 and line C.B12</a:t>
            </a:r>
            <a:r>
              <a:rPr lang="en-GB" sz="11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1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ive viral RNA load (expressed as fold change relative to corresponding time-point Mock control) at specific time-points post-infection: 6hpi, 24hpi and 48hpi. Data points are shown as individual animals (n = 5 per line per time-point) and lines represent mean and standard deviation. Statistically significant differences are highlighted between the lines (#p &lt; 0.01) and within lines across time-points (*p &lt; 0.05, ** p &lt; 0.01). </a:t>
            </a:r>
            <a:endParaRPr lang="en-GB" sz="11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7066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9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en Bryson</dc:creator>
  <cp:lastModifiedBy>MDPI</cp:lastModifiedBy>
  <cp:revision>2</cp:revision>
  <dcterms:created xsi:type="dcterms:W3CDTF">2022-12-12T19:49:38Z</dcterms:created>
  <dcterms:modified xsi:type="dcterms:W3CDTF">2023-02-21T07:14:34Z</dcterms:modified>
</cp:coreProperties>
</file>